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274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2/05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369000" y="7820449"/>
            <a:ext cx="6120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S3 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| Distribution of nanoparticles in the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maternal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lungs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at</a:t>
            </a:r>
            <a:r>
              <a:rPr lang="fr-FR" sz="1000" b="1" dirty="0" smtClean="0">
                <a:latin typeface="Times New Roman" pitchFamily="18" charset="0"/>
                <a:cs typeface="Times New Roman" pitchFamily="18" charset="0"/>
              </a:rPr>
              <a:t> 28 </a:t>
            </a:r>
            <a:r>
              <a:rPr lang="fr-FR" sz="10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Ultrathin sections (75 nm) were obtained from various lung areas 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rostra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or caudal parenchyma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a, c, f, g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;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rostra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r caudal bronchus (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b, d, e, h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.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rrowhaed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ndicate particles in alveoli, small arrowheads indicate NP and arrows thin or not indicate isolated particles.</a:t>
            </a: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cale bars: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a): 20 µm, insert: 10 µm; (b): 2 µm; (c): 600 nm; (d): 1 µm; (e): 500 nm; (f): 160 nm; (g): 700 nm; (h): 500 nm, insert: 400 nm.</a:t>
            </a:r>
          </a:p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Abbreviations: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Br 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brochiolu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; E: erythrocyte ; EC : endothelial cell; Ly 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lysosom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; M  : macrophage ; MC : Smooth muscle cell ; N : nucleus ; NP : nanoparticles ;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nI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: type I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neumocy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fr-FR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 l="11068" t="10776" r="9282" b="15814"/>
          <a:stretch>
            <a:fillRect/>
          </a:stretch>
        </p:blipFill>
        <p:spPr bwMode="auto">
          <a:xfrm>
            <a:off x="418356" y="12700"/>
            <a:ext cx="6021288" cy="78488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3</TotalTime>
  <Words>176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49</cp:revision>
  <dcterms:created xsi:type="dcterms:W3CDTF">2015-02-24T15:36:47Z</dcterms:created>
  <dcterms:modified xsi:type="dcterms:W3CDTF">2016-05-02T16:32:46Z</dcterms:modified>
</cp:coreProperties>
</file>